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5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F8CB4D2-5FB0-4969-A20E-6D6795BCA8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6F907BA5-7E8F-43BB-AE7F-3684864AF3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15DC5AA8-6329-46BF-9BAF-B5EFC373D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E4065A27-99C0-472D-9001-78E7DFF54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3FBD7770-BDA5-443D-A3E2-236F9634C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6150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70E030A5-A971-43F8-9D9D-49A85CDE85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716AA67E-AECA-408A-9515-F544A2EFF0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56F48E4-432F-4CA9-90F7-343919343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9F031C2-D380-4561-B13B-D2D4F465C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882DE7FB-0C96-4E7E-A793-BE5B787DC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24756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D20C2FFF-CEF8-4BFB-A275-A7710E057C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1DA0019B-3507-4FEA-9604-B202B71D3B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AC8000C-7322-4093-BB9E-0FC320E45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53E3AB6F-3F2F-45CE-8695-D9B1A2FD8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30701062-97A7-477A-B740-C0FE82B31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951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D86D69AA-0638-487B-BCBF-9E976D6F53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F1C2148A-F6BD-44F7-98A3-B13F00E94F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D46846B6-8CC2-4DE0-89B7-BC273E402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2CFFB7B1-56D5-45C1-B54C-0F999D958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495679AC-F5CA-479F-9A85-9AD2B6A51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51379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98FF7A3-D3FC-42D7-B673-72F351658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F4000DF6-40D9-47C6-884F-D0176574BB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774C303-D9E2-4793-A39F-173DBA603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ED50C736-A4FF-4E80-948A-FF8B120D4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E14F7C0D-6857-478D-907B-A33970C03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29302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78324EE-7901-4305-9AFA-21855D2ED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1CEBCC7A-FDE3-473D-8AD3-47E8BDEFA9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4953F3E3-AEA8-42F4-BB58-E0FFA65BD5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5C5C8B94-2BCB-4B25-ACA6-D998D0538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FE984FAD-5233-4590-91D6-A465A23C9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8FC6443E-0B26-4456-8740-40C1FC694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52546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BDD61F6F-1E49-47FF-BC91-5B335AC92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1D03AB6E-3621-4A08-AFAB-EC1D842054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1F569D33-453B-4B8B-A4BB-D27C6F8E59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68EF4533-2B2E-475C-AA3A-814D787072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C9033E41-AB72-44FB-855E-1142101138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7BE401BB-AFAF-4E26-B8CD-BAD753E6C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0F046B7D-2031-4B5E-BCEC-6D99EB212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06C1DB71-F38D-4C5B-B005-A882B947C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8165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A0586C8-979B-4F83-A58F-31473D8177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9D722545-4028-4B3F-8819-BEBEBCE75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86D35FD4-FBE7-4465-9AE3-EE92C0240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6669D61C-A0F3-44B5-9E0D-254764E14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76288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D5F16724-B043-4957-9017-34221410D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5004E4C4-A215-41FC-B09D-D39A6BFA2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0D441BAE-0A2D-423E-BF3D-3B2E74C0E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65943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90FF88C-295C-4011-9CDB-8D633E4DF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D0C64BF4-0DA4-4A94-B8D6-58D93C9C17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C45B7BB7-88CC-460B-8D01-891C9D7C55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9509DB6E-EF50-4BB5-A1AA-8DBBABDF2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BEAF4780-F81B-45DF-BD02-8E8AFC48B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4AA8612F-43DF-418B-8A37-6A88FB50D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93334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6DED761-7828-4466-8B5D-56FCFA2D7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E127A4F1-3BDD-456E-9E4A-2722B72EB7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5243BE0F-8AFF-418F-95BC-5337F8137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4C3718-0D7E-4797-9F51-082749FD5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4C3FF14C-B316-43AB-BCD0-19ADC05BD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8CE2F77B-6864-46E7-B941-31337D47D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07061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07792306-300B-4D25-AF2E-6D92D573D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E0AEF7F8-E63D-4F87-A9FE-8F9CD43DAB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1B74A6B-5150-4155-9043-8513973486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AF3D7E27-AA38-4A41-B6FA-C15376A335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FCDC4011-44E8-4F44-91F8-DFD289E27C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21757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="" xmlns:a16="http://schemas.microsoft.com/office/drawing/2014/main" id="{0D02A58B-2F35-4C5B-95A2-16F2905F57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849" y="2127788"/>
            <a:ext cx="11928297" cy="3170099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     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 </a:t>
            </a:r>
            <a:r>
              <a:rPr kumimoji="0" lang="en-US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											     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30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</a:t>
            </a:r>
            <a:r>
              <a:rPr kumimoji="0" lang="ru-RU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A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GT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TGGCC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1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3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AATT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 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GT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TGGCC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ru-RU" altLang="ru-RU" sz="1000" b="1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lang="en-US" altLang="ru-RU" sz="1000" b="1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1.5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en-US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   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TG -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GT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TCC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G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TCG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TGGCCCT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C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A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altLang="ru-RU" sz="10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2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AATTGCA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GT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 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TGGCC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GA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4</a:t>
            </a:r>
            <a:r>
              <a:rPr kumimoji="0" lang="ru-RU" altLang="ru-RU" sz="1000" b="1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AATTGCA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GT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 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C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TGGCC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GA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ru-RU" sz="10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31 </a:t>
            </a:r>
            <a:r>
              <a:rPr lang="en-US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										     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260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1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GTGAG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GCA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A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A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A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 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ACA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TAGAA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TGGG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ATT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3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GTGAG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GCA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A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A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A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 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ACA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TAGAA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TGGG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ATT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ru-RU" altLang="ru-RU" sz="1000" b="1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lang="en-US" altLang="ru-RU" sz="1000" b="1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1.5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GTGAGG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TGCAT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C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TTACT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AAA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AGC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---- --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ACAC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TAGAAA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TGGGCC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TGT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GT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- </a:t>
            </a:r>
            <a:endParaRPr lang="en-US" altLang="ru-RU" sz="10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2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GTGAG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GCA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A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A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A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TTGTA 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ACA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TAGAA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TGGG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ATT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GTC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4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GTGAGG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TGCA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TA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A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AGC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TTGTA C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ACA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TAGAAA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ATGGGC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ATT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GTC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ru-RU" sz="10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     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261 </a:t>
            </a:r>
            <a:r>
              <a:rPr lang="en-US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							      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358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1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----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T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G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TCTA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GGATTC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3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--------G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--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TGC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T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G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TCTA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GGATTC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ru-RU" altLang="ru-RU" sz="1000" b="1" i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lang="en-US" altLang="ru-RU" sz="1000" b="1" i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1.5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---------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TT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--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CT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CTG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CAAGGA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ATCTATA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CC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GGATTCT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ru-RU" altLang="ru-RU" sz="1000" b="1" dirty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ru-RU" altLang="ru-RU" sz="10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T</a:t>
            </a:r>
            <a:r>
              <a:rPr lang="ru-RU" altLang="ru-RU" sz="10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en-US" altLang="ru-RU" sz="10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2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CGAACA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T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 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G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TCTA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GGATTC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ru-RU" altLang="ru-RU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aMyc</a:t>
            </a:r>
            <a:r>
              <a:rPr kumimoji="0" lang="en-US" altLang="ru-RU" sz="1000" b="1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1.4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CGAACAG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A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T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TCTG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 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GGA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ATCTAT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C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TGGATTC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T</a:t>
            </a:r>
            <a:r>
              <a:rPr kumimoji="0" lang="ru-RU" altLang="ru-RU" sz="1000" b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kumimoji="0" lang="en-US" altLang="ru-RU" sz="1000" b="1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Прямоугольник 2">
            <a:extLst>
              <a:ext uri="{FF2B5EF4-FFF2-40B4-BE49-F238E27FC236}">
                <a16:creationId xmlns="" xmlns:a16="http://schemas.microsoft.com/office/drawing/2014/main" id="{A5ABD339-BDD4-4C70-9EC8-8ADBCDE41A78}"/>
              </a:ext>
            </a:extLst>
          </p:cNvPr>
          <p:cNvSpPr/>
          <p:nvPr/>
        </p:nvSpPr>
        <p:spPr>
          <a:xfrm>
            <a:off x="428088" y="924679"/>
            <a:ext cx="11335821" cy="9668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1: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multiple alignment of the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y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s from homoeologous group 2 chromosomes.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ltiple sequence alignment was performed using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ultAlin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gram. Sequences were selected from the International URGI database according [24]. Red is high consensus colour, blue is low consensus colour, black is neutral colour.</a:t>
            </a:r>
            <a:endParaRPr lang="ru-RU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584998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7</Words>
  <Application>Microsoft Office PowerPoint</Application>
  <PresentationFormat>Широкоэкранный</PresentationFormat>
  <Paragraphs>2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5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Ксения Стрыгина</dc:creator>
  <cp:lastModifiedBy>user</cp:lastModifiedBy>
  <cp:revision>3</cp:revision>
  <dcterms:created xsi:type="dcterms:W3CDTF">2018-05-31T16:11:43Z</dcterms:created>
  <dcterms:modified xsi:type="dcterms:W3CDTF">2018-10-08T11:51:20Z</dcterms:modified>
</cp:coreProperties>
</file>